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9906000" cy="6858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5" d="100"/>
          <a:sy n="125" d="100"/>
        </p:scale>
        <p:origin x="-828" y="-72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30428"/>
            <a:ext cx="84201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05DC3-F086-4E4C-9856-BA2F9851D18F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6C41E-0C52-4EE9-9B3C-0519623EF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943618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05DC3-F086-4E4C-9856-BA2F9851D18F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6C41E-0C52-4EE9-9B3C-0519623EF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366743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86387" y="396875"/>
            <a:ext cx="1671638" cy="84518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479" y="396875"/>
            <a:ext cx="4849813" cy="845185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05DC3-F086-4E4C-9856-BA2F9851D18F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6C41E-0C52-4EE9-9B3C-0519623EF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398561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05DC3-F086-4E4C-9856-BA2F9851D18F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6C41E-0C52-4EE9-9B3C-0519623EF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656766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2506" y="2906716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05DC3-F086-4E4C-9856-BA2F9851D18F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6C41E-0C52-4EE9-9B3C-0519623EF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689484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479" y="2311403"/>
            <a:ext cx="3260725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97304" y="2311403"/>
            <a:ext cx="3260725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05DC3-F086-4E4C-9856-BA2F9851D18F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6C41E-0C52-4EE9-9B3C-0519623EF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511289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2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302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32115" y="1535113"/>
            <a:ext cx="4378589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32115" y="2174875"/>
            <a:ext cx="4378589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05DC3-F086-4E4C-9856-BA2F9851D18F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6C41E-0C52-4EE9-9B3C-0519623EF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640818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05DC3-F086-4E4C-9856-BA2F9851D18F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6C41E-0C52-4EE9-9B3C-0519623EF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774022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05DC3-F086-4E4C-9856-BA2F9851D18F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6C41E-0C52-4EE9-9B3C-0519623EF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322329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2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72972" y="273053"/>
            <a:ext cx="553773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302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05DC3-F086-4E4C-9856-BA2F9851D18F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6C41E-0C52-4EE9-9B3C-0519623EF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746306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05DC3-F086-4E4C-9856-BA2F9851D18F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6C41E-0C52-4EE9-9B3C-0519623EF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139167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5300" y="6356353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205DC3-F086-4E4C-9856-BA2F9851D18F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84550" y="6356353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099300" y="6356353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E6C41E-0C52-4EE9-9B3C-0519623EF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587036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741484" y="671933"/>
            <a:ext cx="8505116" cy="4396692"/>
            <a:chOff x="741484" y="1113893"/>
            <a:chExt cx="8505116" cy="4396692"/>
          </a:xfrm>
        </p:grpSpPr>
        <p:grpSp>
          <p:nvGrpSpPr>
            <p:cNvPr id="4" name="Group 3"/>
            <p:cNvGrpSpPr/>
            <p:nvPr/>
          </p:nvGrpSpPr>
          <p:grpSpPr>
            <a:xfrm>
              <a:off x="741484" y="1113893"/>
              <a:ext cx="8505116" cy="4396692"/>
              <a:chOff x="934908" y="1113893"/>
              <a:chExt cx="8505116" cy="4396692"/>
            </a:xfrm>
          </p:grpSpPr>
          <p:pic>
            <p:nvPicPr>
              <p:cNvPr id="2052" name="Picture 4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772" t="20000" r="33489" b="37000"/>
              <a:stretch/>
            </p:blipFill>
            <p:spPr bwMode="auto">
              <a:xfrm>
                <a:off x="1477082" y="1119749"/>
                <a:ext cx="7962942" cy="439083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7" name="Picture 4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323" t="20000" r="87682" b="37000"/>
              <a:stretch/>
            </p:blipFill>
            <p:spPr bwMode="auto">
              <a:xfrm>
                <a:off x="934908" y="1113893"/>
                <a:ext cx="489422" cy="439083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5" name="TextBox 4"/>
            <p:cNvSpPr txBox="1"/>
            <p:nvPr/>
          </p:nvSpPr>
          <p:spPr>
            <a:xfrm>
              <a:off x="2743200" y="2093328"/>
              <a:ext cx="27256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 smtClean="0"/>
                <a:t>*</a:t>
              </a:r>
              <a:endParaRPr lang="en-AU" sz="1100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718752" y="2092235"/>
              <a:ext cx="27256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 smtClean="0"/>
                <a:t>*</a:t>
              </a:r>
              <a:endParaRPr lang="en-AU" sz="1100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811309" y="2094778"/>
              <a:ext cx="27256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 smtClean="0"/>
                <a:t>*</a:t>
              </a:r>
              <a:endParaRPr lang="en-AU" sz="1100" dirty="0"/>
            </a:p>
          </p:txBody>
        </p:sp>
        <p:cxnSp>
          <p:nvCxnSpPr>
            <p:cNvPr id="8" name="Straight Connector 7"/>
            <p:cNvCxnSpPr/>
            <p:nvPr/>
          </p:nvCxnSpPr>
          <p:spPr>
            <a:xfrm>
              <a:off x="4864558" y="1338264"/>
              <a:ext cx="2837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>
              <a:off x="4869305" y="1476375"/>
              <a:ext cx="2837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>
              <a:off x="4870342" y="1609726"/>
              <a:ext cx="2837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>
              <a:off x="4869305" y="1747839"/>
              <a:ext cx="2837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>
              <a:off x="4875105" y="1881189"/>
              <a:ext cx="2837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>
              <a:off x="4875105" y="2014539"/>
              <a:ext cx="2837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/>
          </p:nvCxnSpPr>
          <p:spPr>
            <a:xfrm>
              <a:off x="4875105" y="2157413"/>
              <a:ext cx="2837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/>
          </p:nvCxnSpPr>
          <p:spPr>
            <a:xfrm>
              <a:off x="7945895" y="1471612"/>
              <a:ext cx="2837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/>
            <p:cNvCxnSpPr/>
            <p:nvPr/>
          </p:nvCxnSpPr>
          <p:spPr>
            <a:xfrm>
              <a:off x="7936353" y="1604960"/>
              <a:ext cx="2837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/>
            <p:cNvCxnSpPr/>
            <p:nvPr/>
          </p:nvCxnSpPr>
          <p:spPr>
            <a:xfrm>
              <a:off x="7936353" y="1747838"/>
              <a:ext cx="2837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>
              <a:off x="7956442" y="1881188"/>
              <a:ext cx="2837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/>
          </p:nvCxnSpPr>
          <p:spPr>
            <a:xfrm>
              <a:off x="7804042" y="2014539"/>
              <a:ext cx="2837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/>
            <p:cNvCxnSpPr/>
            <p:nvPr/>
          </p:nvCxnSpPr>
          <p:spPr>
            <a:xfrm>
              <a:off x="1965218" y="2562225"/>
              <a:ext cx="2837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/>
            <p:cNvCxnSpPr/>
            <p:nvPr/>
          </p:nvCxnSpPr>
          <p:spPr>
            <a:xfrm>
              <a:off x="1953998" y="3109912"/>
              <a:ext cx="2837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>
              <a:off x="1953998" y="3248025"/>
              <a:ext cx="2837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/>
            <p:cNvCxnSpPr/>
            <p:nvPr/>
          </p:nvCxnSpPr>
          <p:spPr>
            <a:xfrm>
              <a:off x="2703477" y="3248025"/>
              <a:ext cx="2837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/>
          </p:nvCxnSpPr>
          <p:spPr>
            <a:xfrm>
              <a:off x="5418030" y="3109912"/>
              <a:ext cx="2837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/>
            <p:cNvCxnSpPr/>
            <p:nvPr/>
          </p:nvCxnSpPr>
          <p:spPr>
            <a:xfrm>
              <a:off x="4113105" y="3514724"/>
              <a:ext cx="2837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/>
            <p:cNvCxnSpPr/>
            <p:nvPr/>
          </p:nvCxnSpPr>
          <p:spPr>
            <a:xfrm>
              <a:off x="5276177" y="3652834"/>
              <a:ext cx="2837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Rectangle 17"/>
            <p:cNvSpPr/>
            <p:nvPr/>
          </p:nvSpPr>
          <p:spPr>
            <a:xfrm>
              <a:off x="2827746" y="3405187"/>
              <a:ext cx="1440000" cy="93345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40" name="Rectangle 39"/>
            <p:cNvSpPr/>
            <p:nvPr/>
          </p:nvSpPr>
          <p:spPr>
            <a:xfrm>
              <a:off x="4537961" y="3405187"/>
              <a:ext cx="1362777" cy="93345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304780" y="4268101"/>
              <a:ext cx="5476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ZFD I</a:t>
              </a:r>
              <a:endParaRPr lang="en-AU" sz="1000" dirty="0"/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5031152" y="4263910"/>
              <a:ext cx="5476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ZFD II</a:t>
              </a:r>
              <a:endParaRPr lang="en-AU" sz="1000" dirty="0"/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6618817" y="2096601"/>
              <a:ext cx="27256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 smtClean="0"/>
                <a:t>*</a:t>
              </a:r>
              <a:endParaRPr lang="en-AU" sz="1100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7907867" y="2092796"/>
              <a:ext cx="27256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 smtClean="0"/>
                <a:t>*</a:t>
              </a:r>
              <a:endParaRPr lang="en-AU" sz="1100" dirty="0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8523196" y="2092796"/>
              <a:ext cx="27256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 smtClean="0"/>
                <a:t>*</a:t>
              </a:r>
              <a:endParaRPr lang="en-AU" sz="1100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8933015" y="2095341"/>
              <a:ext cx="27256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 smtClean="0"/>
                <a:t>*</a:t>
              </a:r>
              <a:endParaRPr lang="en-AU" sz="1100" dirty="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3085611" y="3173333"/>
              <a:ext cx="27256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 smtClean="0"/>
                <a:t>*</a:t>
              </a:r>
              <a:endParaRPr lang="en-AU" sz="1100" dirty="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3352311" y="3173333"/>
              <a:ext cx="27256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 smtClean="0"/>
                <a:t>*</a:t>
              </a:r>
              <a:endParaRPr lang="en-AU" sz="1100" dirty="0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4374661" y="3173333"/>
              <a:ext cx="27256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 smtClean="0"/>
                <a:t>*</a:t>
              </a:r>
              <a:endParaRPr lang="en-AU" sz="1100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5530361" y="3173333"/>
              <a:ext cx="27256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 smtClean="0"/>
                <a:t>*</a:t>
              </a:r>
              <a:endParaRPr lang="en-AU" sz="1100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6482861" y="3173333"/>
              <a:ext cx="27256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 smtClean="0"/>
                <a:t>*</a:t>
              </a:r>
              <a:endParaRPr lang="en-AU" sz="1100" dirty="0"/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741484" y="5326380"/>
            <a:ext cx="846409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smtClean="0"/>
              <a:t>Figure. </a:t>
            </a:r>
            <a:r>
              <a:rPr lang="en-GB" sz="1400" b="1" dirty="0"/>
              <a:t>S2</a:t>
            </a:r>
            <a:r>
              <a:rPr lang="en-GB" sz="1400" dirty="0"/>
              <a:t>. </a:t>
            </a:r>
            <a:r>
              <a:rPr lang="en-GB" sz="1400" b="1" dirty="0"/>
              <a:t>Amino acid sequence alignment of glycoprotein </a:t>
            </a:r>
            <a:r>
              <a:rPr lang="en-GB" sz="1400" b="1" dirty="0" err="1"/>
              <a:t>Gn</a:t>
            </a:r>
            <a:r>
              <a:rPr lang="en-GB" sz="1400" b="1" dirty="0"/>
              <a:t> of the DGK group viruses and CCHFV.</a:t>
            </a:r>
            <a:r>
              <a:rPr lang="en-GB" sz="1400" dirty="0"/>
              <a:t> The </a:t>
            </a:r>
            <a:r>
              <a:rPr lang="en-GB" sz="1400" dirty="0" err="1"/>
              <a:t>Gn</a:t>
            </a:r>
            <a:r>
              <a:rPr lang="en-GB" sz="1400" dirty="0"/>
              <a:t> protein contains 12 conserved cysteine residues (*), two zinc finger domains (ZFD I and II). Predicted glycosylation sites are underlined.</a:t>
            </a:r>
            <a:endParaRPr lang="en-AU" sz="1400" dirty="0"/>
          </a:p>
          <a:p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6667984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4</TotalTime>
  <Words>60</Words>
  <Application>Microsoft Office PowerPoint</Application>
  <PresentationFormat>A4 Paper (210x297 mm)</PresentationFormat>
  <Paragraphs>1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DST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uci, Penny</dc:creator>
  <cp:lastModifiedBy>Gauci, Penny</cp:lastModifiedBy>
  <cp:revision>34</cp:revision>
  <cp:lastPrinted>2017-02-14T00:51:40Z</cp:lastPrinted>
  <dcterms:created xsi:type="dcterms:W3CDTF">2017-02-12T23:10:39Z</dcterms:created>
  <dcterms:modified xsi:type="dcterms:W3CDTF">2017-11-01T04:23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hecked by">
    <vt:lpwstr>32123</vt:lpwstr>
  </property>
  <property fmtid="{D5CDD505-2E9C-101B-9397-08002B2CF9AE}" pid="3" name="Objective-Id">
    <vt:lpwstr>AV15014915</vt:lpwstr>
  </property>
  <property fmtid="{D5CDD505-2E9C-101B-9397-08002B2CF9AE}" pid="4" name="Objective-Title">
    <vt:lpwstr>S2 Figure Gn</vt:lpwstr>
  </property>
  <property fmtid="{D5CDD505-2E9C-101B-9397-08002B2CF9AE}" pid="5" name="Objective-Comment">
    <vt:lpwstr>
    </vt:lpwstr>
  </property>
  <property fmtid="{D5CDD505-2E9C-101B-9397-08002B2CF9AE}" pid="6" name="Objective-CreationStamp">
    <vt:filetime>2017-07-31T22:23:12Z</vt:filetime>
  </property>
  <property fmtid="{D5CDD505-2E9C-101B-9397-08002B2CF9AE}" pid="7" name="Objective-IsApproved">
    <vt:bool>false</vt:bool>
  </property>
  <property fmtid="{D5CDD505-2E9C-101B-9397-08002B2CF9AE}" pid="8" name="Objective-IsPublished">
    <vt:bool>false</vt:bool>
  </property>
  <property fmtid="{D5CDD505-2E9C-101B-9397-08002B2CF9AE}" pid="9" name="Objective-DatePublished">
    <vt:lpwstr>
    </vt:lpwstr>
  </property>
  <property fmtid="{D5CDD505-2E9C-101B-9397-08002B2CF9AE}" pid="10" name="Objective-ModificationStamp">
    <vt:filetime>2017-07-31T22:23:43Z</vt:filetime>
  </property>
  <property fmtid="{D5CDD505-2E9C-101B-9397-08002B2CF9AE}" pid="11" name="Objective-Owner">
    <vt:lpwstr>Gauci, Penny (Ms)(DSTO)</vt:lpwstr>
  </property>
  <property fmtid="{D5CDD505-2E9C-101B-9397-08002B2CF9AE}" pid="12" name="Objective-Path">
    <vt:lpwstr>Objective Global Folder - PROD:Defence Business Units:Defence Science and Technology Group:LD : DSTG Land Division:17 MSTC C&amp;BD:Primary Outputs:Research Reports:Virology:Vinegar Hill virus paper:supplementary information:</vt:lpwstr>
  </property>
  <property fmtid="{D5CDD505-2E9C-101B-9397-08002B2CF9AE}" pid="13" name="Objective-Parent">
    <vt:lpwstr>supplementary information</vt:lpwstr>
  </property>
  <property fmtid="{D5CDD505-2E9C-101B-9397-08002B2CF9AE}" pid="14" name="Objective-State">
    <vt:lpwstr>Being Drafted</vt:lpwstr>
  </property>
  <property fmtid="{D5CDD505-2E9C-101B-9397-08002B2CF9AE}" pid="15" name="Objective-Version">
    <vt:lpwstr>0.1</vt:lpwstr>
  </property>
  <property fmtid="{D5CDD505-2E9C-101B-9397-08002B2CF9AE}" pid="16" name="Objective-VersionNumber">
    <vt:i4>1</vt:i4>
  </property>
  <property fmtid="{D5CDD505-2E9C-101B-9397-08002B2CF9AE}" pid="17" name="Objective-VersionComment">
    <vt:lpwstr>First version</vt:lpwstr>
  </property>
  <property fmtid="{D5CDD505-2E9C-101B-9397-08002B2CF9AE}" pid="18" name="Objective-FileNumber">
    <vt:lpwstr>
    </vt:lpwstr>
  </property>
  <property fmtid="{D5CDD505-2E9C-101B-9397-08002B2CF9AE}" pid="19" name="Objective-Classification">
    <vt:lpwstr>[Inherited - Unclassified]</vt:lpwstr>
  </property>
  <property fmtid="{D5CDD505-2E9C-101B-9397-08002B2CF9AE}" pid="20" name="Objective-Caveats">
    <vt:lpwstr>
    </vt:lpwstr>
  </property>
  <property fmtid="{D5CDD505-2E9C-101B-9397-08002B2CF9AE}" pid="21" name="Objective-Document Type [system]">
    <vt:lpwstr>
    </vt:lpwstr>
  </property>
</Properties>
</file>